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48" r:id="rId2"/>
    <p:sldId id="347" r:id="rId3"/>
    <p:sldId id="339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51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83F4DC-CA81-4707-9EA2-05F69A727BEE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9B37BC-3B30-4A31-8A1B-C81B7B298C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66792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E5D968-B19D-4E69-A049-90E86BCAF308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01753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E5D968-B19D-4E69-A049-90E86BCAF308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892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CD2A57-6195-418A-84AD-5474B0B52F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3EDC427-338A-4863-A4F9-469BCCC9CB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0A2BA7-9C2B-4C04-B9E2-24C90E330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0A3EF15-2404-41AA-9FA0-3CB49DB03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125787-BA20-4072-A56D-C235F0256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1309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56B8F7-2092-4BC2-89A2-3587D7C1DA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A666675-6AFA-4489-AC21-2738F893F3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4A6232-B03C-4DD6-AAA9-2EBB7EACA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4C99FD6-1601-43CD-9781-9225B0D9F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801CE3-F55A-42E1-862B-CB61FE793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9341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F72040C-4DE4-4080-A4F6-4CBDC091832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C091A75-F35D-4E82-8A1F-CF2F42D3FF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61E7AD-6956-4F84-BCB6-A743CABD7B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17B29D-36E0-4B93-A370-DB05E2386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0380FE-3EFA-46D5-AB94-42420DCF00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7826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AA6667-19A8-44B2-9CBC-CE925C6140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D6AC6AC-56A9-4038-B83D-C85F5A3360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F8D0CE-5C26-4647-9A83-408916B24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466616E-1D10-4D52-AB9B-35590721B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5EA8CB-E043-40D5-8C79-1627A79BE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7597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4EB397-9D1D-4F6E-A279-A2B4A42AE1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C7EEE3-D207-4E31-ACB5-1283B8E4E8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B47CE4B-05B0-42B7-9C75-183431756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144377-BF91-4D70-AFC8-406F648FF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5E9B9B-3664-48CE-BBB2-B322D8AF1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7542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D92626-DADD-4494-BB14-7E2665A256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A92A1A4-E7B7-4E1D-B66C-FAE1B487B2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0D07E64-76FC-4D29-A1EB-431AB15E05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708E80-A3FE-4EE0-AE1A-E83EC4C1F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3F2B354-C2BC-417D-BB4F-B61498621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D63B53-D290-4C77-AD0D-96A628D4D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6729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50B624-2FD9-4C43-87D2-6ADACB898D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4DF5C3E-D693-4704-809E-4C50790D4A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1FF55A1-C857-4E66-B43C-16EE37B259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80B1630-3666-47FE-B08D-E8694706D7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06D1E64-EE65-459B-9963-2064300533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E5B88C5-5F21-445F-B311-C39FD9489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025C63E-5A85-476C-AD6E-29E0D7ED9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769ACE0-BF7E-4009-AD87-56DA2C055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441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5CA882-0705-46A6-BEAF-457CD0F684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E0AFFF4-3904-4681-B40B-C7542A12E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36207FD-79B4-40E7-A006-1330D01F6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BA1FDCD-C30E-4170-B655-8B16CE2DD7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4321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2EA2899-FE37-4A5F-90AA-CFF4B2BAB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794611D-0566-42AE-A959-23DA0E975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6D25C7D-9E95-413D-94CE-065012A1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1884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454D99-977B-4AC4-BF42-D76CF7D4F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B7D57B-AD88-4B67-945B-75761DF6B0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3F90AAA-F437-47C9-BFD7-F10B3C22B4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CF1DF4C-5463-4B07-A568-2652CE748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A9B629-B2EE-45DF-8C0B-0B0ECDECC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3DC6018-13B8-4796-B0FD-391C5365E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905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154EEB-FE59-4CFA-83FE-4BA18D681F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5CF27B8-490E-4B68-88FB-E80CF6CB14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5C1D385-B4CE-484E-BBE2-57515F055D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537A399-37EA-46CE-9FB3-339F59E82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75FB062-C754-4DCA-9FC5-5CA0E3C19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B53E9ED-0DA9-4407-8B25-CB4447045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9397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CEE09F5-7B2A-4D9C-B3AA-37CC63A135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09A3FB-BC8A-4CCF-B72C-AB0A556972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8FD9445-F3A4-45F3-81F4-C2027F9807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201CE0-0851-4F3D-9F0D-3484A447D07A}" type="datetimeFigureOut">
              <a:rPr lang="zh-CN" altLang="en-US" smtClean="0"/>
              <a:t>2025/10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3E3056-2ED2-43CE-80FF-55D9EFED2E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AF8973-85A4-4CE3-9BEE-2589FDDCD6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60EBB7-B402-4983-8067-9BAD30B9AC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7948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FC3F0B8-AB18-B5AE-A3E0-13AB506EBC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4776"/>
            <a:ext cx="12056533" cy="58438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32789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文本框 28">
            <a:extLst>
              <a:ext uri="{FF2B5EF4-FFF2-40B4-BE49-F238E27FC236}">
                <a16:creationId xmlns:a16="http://schemas.microsoft.com/office/drawing/2014/main" id="{8AC6D637-47F4-4EF0-851B-98EE3EFE3A47}"/>
              </a:ext>
            </a:extLst>
          </p:cNvPr>
          <p:cNvSpPr txBox="1"/>
          <p:nvPr/>
        </p:nvSpPr>
        <p:spPr>
          <a:xfrm>
            <a:off x="-50852" y="21367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B9D627DA-B369-4054-AEBB-9A98A241D3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3199" y="1115008"/>
            <a:ext cx="3023549" cy="3023549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383CDA26-3F6E-44AE-B841-8257CC26578F}"/>
              </a:ext>
            </a:extLst>
          </p:cNvPr>
          <p:cNvSpPr txBox="1"/>
          <p:nvPr/>
        </p:nvSpPr>
        <p:spPr>
          <a:xfrm>
            <a:off x="208248" y="112744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CCA423A-6114-40E0-BC2F-AC987B29AC87}"/>
              </a:ext>
            </a:extLst>
          </p:cNvPr>
          <p:cNvSpPr txBox="1"/>
          <p:nvPr/>
        </p:nvSpPr>
        <p:spPr>
          <a:xfrm>
            <a:off x="3873285" y="112744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D4F806CE-E77A-483B-9518-D8315643B4E8}"/>
              </a:ext>
            </a:extLst>
          </p:cNvPr>
          <p:cNvGrpSpPr/>
          <p:nvPr/>
        </p:nvGrpSpPr>
        <p:grpSpPr>
          <a:xfrm>
            <a:off x="3848538" y="1500054"/>
            <a:ext cx="7872848" cy="2502384"/>
            <a:chOff x="126314" y="1964537"/>
            <a:chExt cx="11459039" cy="3286260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927470D2-1184-4343-9D5E-3B9E1DFDF5B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6314" y="1964538"/>
              <a:ext cx="2861905" cy="2861905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11FA0EB7-C977-46C3-91CF-19231A8BB33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945066" y="1964538"/>
              <a:ext cx="2861905" cy="2861906"/>
            </a:xfrm>
            <a:prstGeom prst="rect">
              <a:avLst/>
            </a:prstGeom>
          </p:spPr>
        </p:pic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5D33B700-842A-4868-9595-DEE4DD85FC95}"/>
                </a:ext>
              </a:extLst>
            </p:cNvPr>
            <p:cNvSpPr txBox="1"/>
            <p:nvPr/>
          </p:nvSpPr>
          <p:spPr>
            <a:xfrm>
              <a:off x="980722" y="4907237"/>
              <a:ext cx="3406928" cy="3435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1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egative Control vs TCFE 0.001%</a:t>
              </a:r>
              <a:endParaRPr kumimoji="1" lang="zh-CN" altLang="en-US" sz="1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BA5C1DCB-EA36-4980-A715-28B0FB12EE04}"/>
                </a:ext>
              </a:extLst>
            </p:cNvPr>
            <p:cNvSpPr txBox="1"/>
            <p:nvPr/>
          </p:nvSpPr>
          <p:spPr>
            <a:xfrm>
              <a:off x="6968776" y="4907237"/>
              <a:ext cx="3406928" cy="3435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1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egative Control vs TCFE 0.005%</a:t>
              </a:r>
              <a:endParaRPr kumimoji="1" lang="zh-CN" altLang="en-US" sz="1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E6CBC745-C15F-4E47-8209-8BB4E9EEB48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84188" y="1964537"/>
              <a:ext cx="2913112" cy="2861905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4AF21FB9-DE7E-4ED4-A827-D06152A8460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672241" y="1964537"/>
              <a:ext cx="2913112" cy="286190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360529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文本框 26"/>
          <p:cNvSpPr txBox="1"/>
          <p:nvPr/>
        </p:nvSpPr>
        <p:spPr>
          <a:xfrm>
            <a:off x="62791" y="2891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D3D86286-2192-481D-A433-E61C21A9F3F9}"/>
              </a:ext>
            </a:extLst>
          </p:cNvPr>
          <p:cNvGrpSpPr/>
          <p:nvPr/>
        </p:nvGrpSpPr>
        <p:grpSpPr>
          <a:xfrm>
            <a:off x="183757" y="3851499"/>
            <a:ext cx="11806458" cy="2941888"/>
            <a:chOff x="170193" y="642141"/>
            <a:chExt cx="11806458" cy="2941888"/>
          </a:xfrm>
        </p:grpSpPr>
        <p:grpSp>
          <p:nvGrpSpPr>
            <p:cNvPr id="24" name="组合 23"/>
            <p:cNvGrpSpPr/>
            <p:nvPr/>
          </p:nvGrpSpPr>
          <p:grpSpPr>
            <a:xfrm>
              <a:off x="9195861" y="644740"/>
              <a:ext cx="2780790" cy="2939289"/>
              <a:chOff x="3601680" y="1081942"/>
              <a:chExt cx="3204636" cy="3119774"/>
            </a:xfrm>
          </p:grpSpPr>
          <p:sp>
            <p:nvSpPr>
              <p:cNvPr id="3" name="文本框 2">
                <a:extLst>
                  <a:ext uri="{FF2B5EF4-FFF2-40B4-BE49-F238E27FC236}">
                    <a16:creationId xmlns:a16="http://schemas.microsoft.com/office/drawing/2014/main" id="{C8FA7483-0250-0342-8B8A-CCFF6CD527DE}"/>
                  </a:ext>
                </a:extLst>
              </p:cNvPr>
              <p:cNvSpPr txBox="1"/>
              <p:nvPr/>
            </p:nvSpPr>
            <p:spPr>
              <a:xfrm>
                <a:off x="4165893" y="3893939"/>
                <a:ext cx="20762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zi0005_vs_NC (</a:t>
                </a:r>
                <a:r>
                  <a:rPr lang="en-US" altLang="zh-CN" sz="1400" dirty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wn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3E6C13D4-65CF-6047-8037-0356571104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601680" y="1081942"/>
                <a:ext cx="3204636" cy="2843127"/>
              </a:xfrm>
              <a:prstGeom prst="rect">
                <a:avLst/>
              </a:prstGeom>
            </p:spPr>
          </p:pic>
          <p:sp>
            <p:nvSpPr>
              <p:cNvPr id="8" name="椭圆 7">
                <a:extLst>
                  <a:ext uri="{FF2B5EF4-FFF2-40B4-BE49-F238E27FC236}">
                    <a16:creationId xmlns:a16="http://schemas.microsoft.com/office/drawing/2014/main" id="{40A444A6-94E5-3A45-B3B8-416170B53F72}"/>
                  </a:ext>
                </a:extLst>
              </p:cNvPr>
              <p:cNvSpPr/>
              <p:nvPr/>
            </p:nvSpPr>
            <p:spPr>
              <a:xfrm>
                <a:off x="4686854" y="3533201"/>
                <a:ext cx="750734" cy="149704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AA89F1D8-B4E3-43EF-B4C2-E6E851556542}"/>
                </a:ext>
              </a:extLst>
            </p:cNvPr>
            <p:cNvGrpSpPr/>
            <p:nvPr/>
          </p:nvGrpSpPr>
          <p:grpSpPr>
            <a:xfrm>
              <a:off x="6175512" y="644739"/>
              <a:ext cx="2945675" cy="2938075"/>
              <a:chOff x="6096000" y="644739"/>
              <a:chExt cx="2945675" cy="2938075"/>
            </a:xfrm>
          </p:grpSpPr>
          <p:sp>
            <p:nvSpPr>
              <p:cNvPr id="2" name="文本框 1">
                <a:extLst>
                  <a:ext uri="{FF2B5EF4-FFF2-40B4-BE49-F238E27FC236}">
                    <a16:creationId xmlns:a16="http://schemas.microsoft.com/office/drawing/2014/main" id="{DA2469FD-99B3-2443-A908-632C586F8D65}"/>
                  </a:ext>
                </a:extLst>
              </p:cNvPr>
              <p:cNvSpPr txBox="1"/>
              <p:nvPr/>
            </p:nvSpPr>
            <p:spPr>
              <a:xfrm>
                <a:off x="6599310" y="3288807"/>
                <a:ext cx="1939054" cy="2940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zi0001_vs_NC (</a:t>
                </a:r>
                <a:r>
                  <a:rPr lang="en-US" altLang="zh-CN" sz="1400" dirty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wn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6519AE53-4E73-904C-8F9D-F76CFB9642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096000" y="644739"/>
                <a:ext cx="2945675" cy="2673033"/>
              </a:xfrm>
              <a:prstGeom prst="rect">
                <a:avLst/>
              </a:prstGeom>
            </p:spPr>
          </p:pic>
          <p:sp>
            <p:nvSpPr>
              <p:cNvPr id="7" name="椭圆 6">
                <a:extLst>
                  <a:ext uri="{FF2B5EF4-FFF2-40B4-BE49-F238E27FC236}">
                    <a16:creationId xmlns:a16="http://schemas.microsoft.com/office/drawing/2014/main" id="{8217D574-58EE-864B-B230-7C17D6446797}"/>
                  </a:ext>
                </a:extLst>
              </p:cNvPr>
              <p:cNvSpPr/>
              <p:nvPr/>
            </p:nvSpPr>
            <p:spPr>
              <a:xfrm>
                <a:off x="6989605" y="2509711"/>
                <a:ext cx="701140" cy="143006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椭圆 8">
                <a:extLst>
                  <a:ext uri="{FF2B5EF4-FFF2-40B4-BE49-F238E27FC236}">
                    <a16:creationId xmlns:a16="http://schemas.microsoft.com/office/drawing/2014/main" id="{37EE2163-CDDB-8045-AE1A-C2F510B8CD0D}"/>
                  </a:ext>
                </a:extLst>
              </p:cNvPr>
              <p:cNvSpPr/>
              <p:nvPr/>
            </p:nvSpPr>
            <p:spPr>
              <a:xfrm>
                <a:off x="6444282" y="1166850"/>
                <a:ext cx="1437676" cy="186220"/>
              </a:xfrm>
              <a:prstGeom prst="ellipse">
                <a:avLst/>
              </a:prstGeom>
              <a:no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椭圆 9">
                <a:extLst>
                  <a:ext uri="{FF2B5EF4-FFF2-40B4-BE49-F238E27FC236}">
                    <a16:creationId xmlns:a16="http://schemas.microsoft.com/office/drawing/2014/main" id="{3D34509B-0D89-0F4A-B3C7-949841285F31}"/>
                  </a:ext>
                </a:extLst>
              </p:cNvPr>
              <p:cNvSpPr/>
              <p:nvPr/>
            </p:nvSpPr>
            <p:spPr>
              <a:xfrm>
                <a:off x="6444282" y="1776204"/>
                <a:ext cx="1437676" cy="186220"/>
              </a:xfrm>
              <a:prstGeom prst="ellipse">
                <a:avLst/>
              </a:prstGeom>
              <a:no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椭圆 10">
                <a:extLst>
                  <a:ext uri="{FF2B5EF4-FFF2-40B4-BE49-F238E27FC236}">
                    <a16:creationId xmlns:a16="http://schemas.microsoft.com/office/drawing/2014/main" id="{5CA68520-A58E-6D4E-894F-DC386C0C893F}"/>
                  </a:ext>
                </a:extLst>
              </p:cNvPr>
              <p:cNvSpPr/>
              <p:nvPr/>
            </p:nvSpPr>
            <p:spPr>
              <a:xfrm>
                <a:off x="6344890" y="2901999"/>
                <a:ext cx="1437676" cy="186220"/>
              </a:xfrm>
              <a:prstGeom prst="ellipse">
                <a:avLst/>
              </a:prstGeom>
              <a:no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1966C5EA-2EB8-4F66-92F6-8A98238C8FC0}"/>
                </a:ext>
              </a:extLst>
            </p:cNvPr>
            <p:cNvGrpSpPr/>
            <p:nvPr/>
          </p:nvGrpSpPr>
          <p:grpSpPr>
            <a:xfrm>
              <a:off x="170193" y="642141"/>
              <a:ext cx="5922427" cy="2941887"/>
              <a:chOff x="123276" y="687634"/>
              <a:chExt cx="8429325" cy="4372732"/>
            </a:xfrm>
          </p:grpSpPr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9425E904-22B0-4347-A888-10B0F0BB7A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23276" y="687634"/>
                <a:ext cx="4192547" cy="3978770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9E16352A-A273-4C19-9E37-9E4C1595905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360054" y="687634"/>
                <a:ext cx="4192547" cy="3978770"/>
              </a:xfrm>
              <a:prstGeom prst="rect">
                <a:avLst/>
              </a:prstGeom>
            </p:spPr>
          </p:pic>
          <p:sp>
            <p:nvSpPr>
              <p:cNvPr id="32" name="椭圆 31">
                <a:extLst>
                  <a:ext uri="{FF2B5EF4-FFF2-40B4-BE49-F238E27FC236}">
                    <a16:creationId xmlns:a16="http://schemas.microsoft.com/office/drawing/2014/main" id="{677C72A4-3B0C-425A-9A99-34BA5EDF1C93}"/>
                  </a:ext>
                </a:extLst>
              </p:cNvPr>
              <p:cNvSpPr/>
              <p:nvPr/>
            </p:nvSpPr>
            <p:spPr>
              <a:xfrm>
                <a:off x="581804" y="3010612"/>
                <a:ext cx="1985402" cy="268946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椭圆 32">
                <a:extLst>
                  <a:ext uri="{FF2B5EF4-FFF2-40B4-BE49-F238E27FC236}">
                    <a16:creationId xmlns:a16="http://schemas.microsoft.com/office/drawing/2014/main" id="{ADFA0CFC-8F39-4117-B4D9-577ABE06DA3A}"/>
                  </a:ext>
                </a:extLst>
              </p:cNvPr>
              <p:cNvSpPr/>
              <p:nvPr/>
            </p:nvSpPr>
            <p:spPr>
              <a:xfrm>
                <a:off x="5440322" y="3264555"/>
                <a:ext cx="1327494" cy="210177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椭圆 35">
                <a:extLst>
                  <a:ext uri="{FF2B5EF4-FFF2-40B4-BE49-F238E27FC236}">
                    <a16:creationId xmlns:a16="http://schemas.microsoft.com/office/drawing/2014/main" id="{5AFAEB48-C725-4E26-8EAF-3CE18C48BD55}"/>
                  </a:ext>
                </a:extLst>
              </p:cNvPr>
              <p:cNvSpPr/>
              <p:nvPr/>
            </p:nvSpPr>
            <p:spPr>
              <a:xfrm>
                <a:off x="1028253" y="2620096"/>
                <a:ext cx="1444650" cy="175222"/>
              </a:xfrm>
              <a:prstGeom prst="ellipse">
                <a:avLst/>
              </a:prstGeom>
              <a:no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00CD350D-44F9-481B-B5A5-1D27A28C0957}"/>
                  </a:ext>
                </a:extLst>
              </p:cNvPr>
              <p:cNvSpPr txBox="1"/>
              <p:nvPr/>
            </p:nvSpPr>
            <p:spPr>
              <a:xfrm>
                <a:off x="934749" y="4625823"/>
                <a:ext cx="2502746" cy="4345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zi0001_vs_NC (</a:t>
                </a:r>
                <a:r>
                  <a:rPr lang="en-US" altLang="zh-CN" sz="14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159BC51B-E6BE-4E5A-9F60-04C57C0B670D}"/>
                  </a:ext>
                </a:extLst>
              </p:cNvPr>
              <p:cNvSpPr txBox="1"/>
              <p:nvPr/>
            </p:nvSpPr>
            <p:spPr>
              <a:xfrm>
                <a:off x="5021471" y="4595974"/>
                <a:ext cx="2502746" cy="4345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zi0005_vs_NC (</a:t>
                </a:r>
                <a:r>
                  <a:rPr lang="en-US" altLang="zh-CN" sz="14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5" name="文本框 24">
            <a:extLst>
              <a:ext uri="{FF2B5EF4-FFF2-40B4-BE49-F238E27FC236}">
                <a16:creationId xmlns:a16="http://schemas.microsoft.com/office/drawing/2014/main" id="{22DA86E2-C88B-4316-B7E0-8BA3B79F1FB2}"/>
              </a:ext>
            </a:extLst>
          </p:cNvPr>
          <p:cNvSpPr txBox="1"/>
          <p:nvPr/>
        </p:nvSpPr>
        <p:spPr>
          <a:xfrm>
            <a:off x="-50852" y="21367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372E067-A984-4A15-9C86-880EEDD75E7F}"/>
              </a:ext>
            </a:extLst>
          </p:cNvPr>
          <p:cNvSpPr txBox="1"/>
          <p:nvPr/>
        </p:nvSpPr>
        <p:spPr>
          <a:xfrm>
            <a:off x="62791" y="351738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99CF52D2-90CF-460C-ADEF-CB09485FA40F}"/>
              </a:ext>
            </a:extLst>
          </p:cNvPr>
          <p:cNvGrpSpPr/>
          <p:nvPr/>
        </p:nvGrpSpPr>
        <p:grpSpPr>
          <a:xfrm>
            <a:off x="183757" y="626657"/>
            <a:ext cx="11800221" cy="2821420"/>
            <a:chOff x="170193" y="3959300"/>
            <a:chExt cx="11800221" cy="2821420"/>
          </a:xfrm>
        </p:grpSpPr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7A37A6F2-3D53-4024-850F-191BE57329B1}"/>
                </a:ext>
              </a:extLst>
            </p:cNvPr>
            <p:cNvGrpSpPr/>
            <p:nvPr/>
          </p:nvGrpSpPr>
          <p:grpSpPr>
            <a:xfrm>
              <a:off x="170193" y="3959300"/>
              <a:ext cx="5922427" cy="2821420"/>
              <a:chOff x="6285883" y="727907"/>
              <a:chExt cx="8574933" cy="4463649"/>
            </a:xfrm>
          </p:grpSpPr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A78D2EDB-8B91-4C88-BDE2-1826F2C2DFD2}"/>
                  </a:ext>
                </a:extLst>
              </p:cNvPr>
              <p:cNvSpPr txBox="1"/>
              <p:nvPr/>
            </p:nvSpPr>
            <p:spPr>
              <a:xfrm>
                <a:off x="7138502" y="4661282"/>
                <a:ext cx="2872807" cy="4869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zi0001_vs_NC (</a:t>
                </a:r>
                <a:r>
                  <a:rPr lang="en-US" altLang="zh-CN" sz="14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768CD396-10CF-42B3-9DB6-9A5B288FE6D6}"/>
                  </a:ext>
                </a:extLst>
              </p:cNvPr>
              <p:cNvSpPr txBox="1"/>
              <p:nvPr/>
            </p:nvSpPr>
            <p:spPr>
              <a:xfrm>
                <a:off x="11394475" y="4704635"/>
                <a:ext cx="2666844" cy="4869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zi0005_vs_NC (</a:t>
                </a:r>
                <a:r>
                  <a:rPr lang="en-US" altLang="zh-CN" sz="14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4F8A5354-536B-4111-B3D3-A96E8AAAD0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285883" y="727907"/>
                <a:ext cx="4275628" cy="4008459"/>
              </a:xfrm>
              <a:prstGeom prst="rect">
                <a:avLst/>
              </a:prstGeom>
            </p:spPr>
          </p:pic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F6A92085-8158-4CAC-8932-C2CD3A5B6C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0585188" y="727907"/>
                <a:ext cx="4275628" cy="4008458"/>
              </a:xfrm>
              <a:prstGeom prst="rect">
                <a:avLst/>
              </a:prstGeom>
            </p:spPr>
          </p:pic>
          <p:sp>
            <p:nvSpPr>
              <p:cNvPr id="42" name="椭圆 41">
                <a:extLst>
                  <a:ext uri="{FF2B5EF4-FFF2-40B4-BE49-F238E27FC236}">
                    <a16:creationId xmlns:a16="http://schemas.microsoft.com/office/drawing/2014/main" id="{E9A3E882-6296-461C-823A-B9E7A261EA22}"/>
                  </a:ext>
                </a:extLst>
              </p:cNvPr>
              <p:cNvSpPr/>
              <p:nvPr/>
            </p:nvSpPr>
            <p:spPr>
              <a:xfrm>
                <a:off x="7311218" y="1963244"/>
                <a:ext cx="1324806" cy="213014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椭圆 42">
                <a:extLst>
                  <a:ext uri="{FF2B5EF4-FFF2-40B4-BE49-F238E27FC236}">
                    <a16:creationId xmlns:a16="http://schemas.microsoft.com/office/drawing/2014/main" id="{C4EB53C4-948C-41ED-B12D-F2628090CB8E}"/>
                  </a:ext>
                </a:extLst>
              </p:cNvPr>
              <p:cNvSpPr/>
              <p:nvPr/>
            </p:nvSpPr>
            <p:spPr>
              <a:xfrm>
                <a:off x="7236677" y="1301115"/>
                <a:ext cx="1324806" cy="213014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椭圆 43">
                <a:extLst>
                  <a:ext uri="{FF2B5EF4-FFF2-40B4-BE49-F238E27FC236}">
                    <a16:creationId xmlns:a16="http://schemas.microsoft.com/office/drawing/2014/main" id="{EF11716E-0D3C-4121-95D0-1FF0F8D82A75}"/>
                  </a:ext>
                </a:extLst>
              </p:cNvPr>
              <p:cNvSpPr/>
              <p:nvPr/>
            </p:nvSpPr>
            <p:spPr>
              <a:xfrm>
                <a:off x="11598465" y="1750230"/>
                <a:ext cx="1324806" cy="213014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椭圆 44">
                <a:extLst>
                  <a:ext uri="{FF2B5EF4-FFF2-40B4-BE49-F238E27FC236}">
                    <a16:creationId xmlns:a16="http://schemas.microsoft.com/office/drawing/2014/main" id="{BDE1A36A-727C-42AC-8BC9-04AE5D2EFB9A}"/>
                  </a:ext>
                </a:extLst>
              </p:cNvPr>
              <p:cNvSpPr/>
              <p:nvPr/>
            </p:nvSpPr>
            <p:spPr>
              <a:xfrm>
                <a:off x="11529792" y="3061735"/>
                <a:ext cx="1324805" cy="213015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3B7A3D70-1FA0-4407-9B51-0FC2CEFC6143}"/>
                </a:ext>
              </a:extLst>
            </p:cNvPr>
            <p:cNvGrpSpPr/>
            <p:nvPr/>
          </p:nvGrpSpPr>
          <p:grpSpPr>
            <a:xfrm>
              <a:off x="6161055" y="3960666"/>
              <a:ext cx="5809359" cy="2794157"/>
              <a:chOff x="6180160" y="4591232"/>
              <a:chExt cx="5966542" cy="3081984"/>
            </a:xfrm>
          </p:grpSpPr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62A7EEC4-E01A-4D28-98BC-57CA34837C93}"/>
                  </a:ext>
                </a:extLst>
              </p:cNvPr>
              <p:cNvSpPr txBox="1"/>
              <p:nvPr/>
            </p:nvSpPr>
            <p:spPr>
              <a:xfrm>
                <a:off x="6683945" y="7377548"/>
                <a:ext cx="1939054" cy="2940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zi0001_vs_NC (</a:t>
                </a:r>
                <a:r>
                  <a:rPr lang="en-US" altLang="zh-CN" sz="1400" dirty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wn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439B2944-987F-4558-8721-0A9CA744CF2D}"/>
                  </a:ext>
                </a:extLst>
              </p:cNvPr>
              <p:cNvSpPr txBox="1"/>
              <p:nvPr/>
            </p:nvSpPr>
            <p:spPr>
              <a:xfrm>
                <a:off x="9795465" y="7379209"/>
                <a:ext cx="1939054" cy="2940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zi0005_vs_NC (</a:t>
                </a:r>
                <a:r>
                  <a:rPr lang="en-US" altLang="zh-CN" sz="1400" dirty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wn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9" name="图片 48">
                <a:extLst>
                  <a:ext uri="{FF2B5EF4-FFF2-40B4-BE49-F238E27FC236}">
                    <a16:creationId xmlns:a16="http://schemas.microsoft.com/office/drawing/2014/main" id="{4AE8FD80-C018-4313-BEB3-3933089FD2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180160" y="4591232"/>
                <a:ext cx="3040224" cy="2786316"/>
              </a:xfrm>
              <a:prstGeom prst="rect">
                <a:avLst/>
              </a:prstGeom>
            </p:spPr>
          </p:pic>
          <p:pic>
            <p:nvPicPr>
              <p:cNvPr id="50" name="图片 49">
                <a:extLst>
                  <a:ext uri="{FF2B5EF4-FFF2-40B4-BE49-F238E27FC236}">
                    <a16:creationId xmlns:a16="http://schemas.microsoft.com/office/drawing/2014/main" id="{2547111E-9306-4589-8CBF-5DB06C8366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9290671" y="4591233"/>
                <a:ext cx="2856031" cy="2779370"/>
              </a:xfrm>
              <a:prstGeom prst="rect">
                <a:avLst/>
              </a:prstGeom>
            </p:spPr>
          </p:pic>
          <p:sp>
            <p:nvSpPr>
              <p:cNvPr id="51" name="椭圆 50">
                <a:extLst>
                  <a:ext uri="{FF2B5EF4-FFF2-40B4-BE49-F238E27FC236}">
                    <a16:creationId xmlns:a16="http://schemas.microsoft.com/office/drawing/2014/main" id="{4DE5A0E3-4C04-4504-8557-9872AB537DD8}"/>
                  </a:ext>
                </a:extLst>
              </p:cNvPr>
              <p:cNvSpPr/>
              <p:nvPr/>
            </p:nvSpPr>
            <p:spPr>
              <a:xfrm>
                <a:off x="6902988" y="6215309"/>
                <a:ext cx="929913" cy="146517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椭圆 51">
                <a:extLst>
                  <a:ext uri="{FF2B5EF4-FFF2-40B4-BE49-F238E27FC236}">
                    <a16:creationId xmlns:a16="http://schemas.microsoft.com/office/drawing/2014/main" id="{32E98A9F-6B89-443B-AD31-E0D967EA1EFC}"/>
                  </a:ext>
                </a:extLst>
              </p:cNvPr>
              <p:cNvSpPr/>
              <p:nvPr/>
            </p:nvSpPr>
            <p:spPr>
              <a:xfrm>
                <a:off x="6902987" y="6829694"/>
                <a:ext cx="929913" cy="146517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椭圆 52">
                <a:extLst>
                  <a:ext uri="{FF2B5EF4-FFF2-40B4-BE49-F238E27FC236}">
                    <a16:creationId xmlns:a16="http://schemas.microsoft.com/office/drawing/2014/main" id="{104F3335-DB3D-4B96-BC1A-6D128A773C19}"/>
                  </a:ext>
                </a:extLst>
              </p:cNvPr>
              <p:cNvSpPr/>
              <p:nvPr/>
            </p:nvSpPr>
            <p:spPr>
              <a:xfrm>
                <a:off x="7005187" y="7123226"/>
                <a:ext cx="827715" cy="146517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椭圆 53">
                <a:extLst>
                  <a:ext uri="{FF2B5EF4-FFF2-40B4-BE49-F238E27FC236}">
                    <a16:creationId xmlns:a16="http://schemas.microsoft.com/office/drawing/2014/main" id="{62CC71A7-6F30-4CD9-BC51-222B644E21EB}"/>
                  </a:ext>
                </a:extLst>
              </p:cNvPr>
              <p:cNvSpPr/>
              <p:nvPr/>
            </p:nvSpPr>
            <p:spPr>
              <a:xfrm>
                <a:off x="9933833" y="5574594"/>
                <a:ext cx="929913" cy="146517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椭圆 54">
                <a:extLst>
                  <a:ext uri="{FF2B5EF4-FFF2-40B4-BE49-F238E27FC236}">
                    <a16:creationId xmlns:a16="http://schemas.microsoft.com/office/drawing/2014/main" id="{F2335D80-B430-4E6D-8C81-3078354C22E1}"/>
                  </a:ext>
                </a:extLst>
              </p:cNvPr>
              <p:cNvSpPr/>
              <p:nvPr/>
            </p:nvSpPr>
            <p:spPr>
              <a:xfrm>
                <a:off x="9861841" y="4969438"/>
                <a:ext cx="929913" cy="146517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49986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6</Words>
  <Application>Microsoft Office PowerPoint</Application>
  <PresentationFormat>Widescreen</PresentationFormat>
  <Paragraphs>18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Gang</dc:creator>
  <cp:lastModifiedBy>MDPI</cp:lastModifiedBy>
  <cp:revision>3</cp:revision>
  <dcterms:created xsi:type="dcterms:W3CDTF">2025-08-19T07:03:04Z</dcterms:created>
  <dcterms:modified xsi:type="dcterms:W3CDTF">2025-10-22T09:44:13Z</dcterms:modified>
</cp:coreProperties>
</file>